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7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84" userDrawn="1">
          <p15:clr>
            <a:srgbClr val="A4A3A4"/>
          </p15:clr>
        </p15:guide>
        <p15:guide id="2" pos="244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6719C"/>
    <a:srgbClr val="555AD3"/>
    <a:srgbClr val="0068F0"/>
    <a:srgbClr val="FF9694"/>
    <a:srgbClr val="FF9D9D"/>
    <a:srgbClr val="CF6154"/>
    <a:srgbClr val="8FAADC"/>
    <a:srgbClr val="C5E0B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190"/>
    <p:restoredTop sz="94672"/>
  </p:normalViewPr>
  <p:slideViewPr>
    <p:cSldViewPr snapToGrid="0" snapToObjects="1">
      <p:cViewPr>
        <p:scale>
          <a:sx n="115" d="100"/>
          <a:sy n="115" d="100"/>
        </p:scale>
        <p:origin x="4104" y="-88"/>
      </p:cViewPr>
      <p:guideLst>
        <p:guide orient="horz" pos="3384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DB6FC9-0008-A043-AB12-BDE08D1EC6B5}" type="datetimeFigureOut">
              <a:rPr lang="en-US" smtClean="0"/>
              <a:t>5/16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5C9DFC-CA46-4242-8D78-02FCC6C317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7857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986F6-B0BC-974A-9293-AA43ED3B912B}" type="datetimeFigureOut">
              <a:rPr lang="en-US" smtClean="0"/>
              <a:t>5/1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7907C-B43F-EA41-90E9-34CE7080EA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38283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986F6-B0BC-974A-9293-AA43ED3B912B}" type="datetimeFigureOut">
              <a:rPr lang="en-US" smtClean="0"/>
              <a:t>5/1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7907C-B43F-EA41-90E9-34CE7080EA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2320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986F6-B0BC-974A-9293-AA43ED3B912B}" type="datetimeFigureOut">
              <a:rPr lang="en-US" smtClean="0"/>
              <a:t>5/1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7907C-B43F-EA41-90E9-34CE7080EA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94441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986F6-B0BC-974A-9293-AA43ED3B912B}" type="datetimeFigureOut">
              <a:rPr lang="en-US" smtClean="0"/>
              <a:t>5/1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7907C-B43F-EA41-90E9-34CE7080EA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91786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986F6-B0BC-974A-9293-AA43ED3B912B}" type="datetimeFigureOut">
              <a:rPr lang="en-US" smtClean="0"/>
              <a:t>5/1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7907C-B43F-EA41-90E9-34CE7080EA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60326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986F6-B0BC-974A-9293-AA43ED3B912B}" type="datetimeFigureOut">
              <a:rPr lang="en-US" smtClean="0"/>
              <a:t>5/16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7907C-B43F-EA41-90E9-34CE7080EA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81094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986F6-B0BC-974A-9293-AA43ED3B912B}" type="datetimeFigureOut">
              <a:rPr lang="en-US" smtClean="0"/>
              <a:t>5/16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7907C-B43F-EA41-90E9-34CE7080EA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88785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986F6-B0BC-974A-9293-AA43ED3B912B}" type="datetimeFigureOut">
              <a:rPr lang="en-US" smtClean="0"/>
              <a:t>5/16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7907C-B43F-EA41-90E9-34CE7080EA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45693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986F6-B0BC-974A-9293-AA43ED3B912B}" type="datetimeFigureOut">
              <a:rPr lang="en-US" smtClean="0"/>
              <a:t>5/16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7907C-B43F-EA41-90E9-34CE7080EA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95505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986F6-B0BC-974A-9293-AA43ED3B912B}" type="datetimeFigureOut">
              <a:rPr lang="en-US" smtClean="0"/>
              <a:t>5/16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7907C-B43F-EA41-90E9-34CE7080EA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38651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986F6-B0BC-974A-9293-AA43ED3B912B}" type="datetimeFigureOut">
              <a:rPr lang="en-US" smtClean="0"/>
              <a:t>5/16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17907C-B43F-EA41-90E9-34CE7080EA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14434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A986F6-B0BC-974A-9293-AA43ED3B912B}" type="datetimeFigureOut">
              <a:rPr lang="en-US" smtClean="0"/>
              <a:t>5/1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17907C-B43F-EA41-90E9-34CE7080EA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2400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Parallelogram 97">
            <a:extLst>
              <a:ext uri="{FF2B5EF4-FFF2-40B4-BE49-F238E27FC236}">
                <a16:creationId xmlns:a16="http://schemas.microsoft.com/office/drawing/2014/main" id="{50B4088D-E0D9-A24E-9D9A-A9F35B794AE5}"/>
              </a:ext>
            </a:extLst>
          </p:cNvPr>
          <p:cNvSpPr/>
          <p:nvPr/>
        </p:nvSpPr>
        <p:spPr>
          <a:xfrm>
            <a:off x="3284081" y="466746"/>
            <a:ext cx="274817" cy="499373"/>
          </a:xfrm>
          <a:custGeom>
            <a:avLst/>
            <a:gdLst>
              <a:gd name="connsiteX0" fmla="*/ 0 w 563018"/>
              <a:gd name="connsiteY0" fmla="*/ 475103 h 475103"/>
              <a:gd name="connsiteX1" fmla="*/ 7264 w 563018"/>
              <a:gd name="connsiteY1" fmla="*/ 0 h 475103"/>
              <a:gd name="connsiteX2" fmla="*/ 563018 w 563018"/>
              <a:gd name="connsiteY2" fmla="*/ 0 h 475103"/>
              <a:gd name="connsiteX3" fmla="*/ 555754 w 563018"/>
              <a:gd name="connsiteY3" fmla="*/ 475103 h 475103"/>
              <a:gd name="connsiteX4" fmla="*/ 0 w 563018"/>
              <a:gd name="connsiteY4" fmla="*/ 475103 h 475103"/>
              <a:gd name="connsiteX0" fmla="*/ 0 w 563018"/>
              <a:gd name="connsiteY0" fmla="*/ 475103 h 486255"/>
              <a:gd name="connsiteX1" fmla="*/ 7264 w 563018"/>
              <a:gd name="connsiteY1" fmla="*/ 0 h 486255"/>
              <a:gd name="connsiteX2" fmla="*/ 563018 w 563018"/>
              <a:gd name="connsiteY2" fmla="*/ 0 h 486255"/>
              <a:gd name="connsiteX3" fmla="*/ 499998 w 563018"/>
              <a:gd name="connsiteY3" fmla="*/ 486255 h 486255"/>
              <a:gd name="connsiteX4" fmla="*/ 0 w 563018"/>
              <a:gd name="connsiteY4" fmla="*/ 475103 h 486255"/>
              <a:gd name="connsiteX0" fmla="*/ 0 w 585320"/>
              <a:gd name="connsiteY0" fmla="*/ 536435 h 547587"/>
              <a:gd name="connsiteX1" fmla="*/ 7264 w 585320"/>
              <a:gd name="connsiteY1" fmla="*/ 61332 h 547587"/>
              <a:gd name="connsiteX2" fmla="*/ 585320 w 585320"/>
              <a:gd name="connsiteY2" fmla="*/ 0 h 547587"/>
              <a:gd name="connsiteX3" fmla="*/ 499998 w 585320"/>
              <a:gd name="connsiteY3" fmla="*/ 547587 h 547587"/>
              <a:gd name="connsiteX4" fmla="*/ 0 w 585320"/>
              <a:gd name="connsiteY4" fmla="*/ 536435 h 547587"/>
              <a:gd name="connsiteX0" fmla="*/ 0 w 611762"/>
              <a:gd name="connsiteY0" fmla="*/ 536435 h 593075"/>
              <a:gd name="connsiteX1" fmla="*/ 7264 w 611762"/>
              <a:gd name="connsiteY1" fmla="*/ 61332 h 593075"/>
              <a:gd name="connsiteX2" fmla="*/ 585320 w 611762"/>
              <a:gd name="connsiteY2" fmla="*/ 0 h 593075"/>
              <a:gd name="connsiteX3" fmla="*/ 611762 w 611762"/>
              <a:gd name="connsiteY3" fmla="*/ 593075 h 593075"/>
              <a:gd name="connsiteX4" fmla="*/ 0 w 611762"/>
              <a:gd name="connsiteY4" fmla="*/ 536435 h 593075"/>
              <a:gd name="connsiteX0" fmla="*/ 0 w 611762"/>
              <a:gd name="connsiteY0" fmla="*/ 475102 h 531742"/>
              <a:gd name="connsiteX1" fmla="*/ 7264 w 611762"/>
              <a:gd name="connsiteY1" fmla="*/ -1 h 531742"/>
              <a:gd name="connsiteX2" fmla="*/ 484731 w 611762"/>
              <a:gd name="connsiteY2" fmla="*/ 3649 h 531742"/>
              <a:gd name="connsiteX3" fmla="*/ 611762 w 611762"/>
              <a:gd name="connsiteY3" fmla="*/ 531742 h 531742"/>
              <a:gd name="connsiteX4" fmla="*/ 0 w 611762"/>
              <a:gd name="connsiteY4" fmla="*/ 475102 h 53174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611762" h="531742">
                <a:moveTo>
                  <a:pt x="0" y="475102"/>
                </a:moveTo>
                <a:lnTo>
                  <a:pt x="7264" y="-1"/>
                </a:lnTo>
                <a:lnTo>
                  <a:pt x="484731" y="3649"/>
                </a:lnTo>
                <a:lnTo>
                  <a:pt x="611762" y="531742"/>
                </a:lnTo>
                <a:lnTo>
                  <a:pt x="0" y="475102"/>
                </a:lnTo>
                <a:close/>
              </a:path>
            </a:pathLst>
          </a:custGeom>
          <a:solidFill>
            <a:schemeClr val="accent1">
              <a:lumMod val="20000"/>
              <a:lumOff val="80000"/>
              <a:alpha val="40000"/>
            </a:schemeClr>
          </a:solidFill>
          <a:ln w="6350">
            <a:solidFill>
              <a:schemeClr val="accent1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" name="Parallelogram 97">
            <a:extLst>
              <a:ext uri="{FF2B5EF4-FFF2-40B4-BE49-F238E27FC236}">
                <a16:creationId xmlns:a16="http://schemas.microsoft.com/office/drawing/2014/main" id="{F07723B7-CEFC-3F43-9D31-18C2F7A457D2}"/>
              </a:ext>
            </a:extLst>
          </p:cNvPr>
          <p:cNvSpPr/>
          <p:nvPr/>
        </p:nvSpPr>
        <p:spPr>
          <a:xfrm>
            <a:off x="3628396" y="414895"/>
            <a:ext cx="244096" cy="559741"/>
          </a:xfrm>
          <a:custGeom>
            <a:avLst/>
            <a:gdLst>
              <a:gd name="connsiteX0" fmla="*/ 0 w 563018"/>
              <a:gd name="connsiteY0" fmla="*/ 475103 h 475103"/>
              <a:gd name="connsiteX1" fmla="*/ 7264 w 563018"/>
              <a:gd name="connsiteY1" fmla="*/ 0 h 475103"/>
              <a:gd name="connsiteX2" fmla="*/ 563018 w 563018"/>
              <a:gd name="connsiteY2" fmla="*/ 0 h 475103"/>
              <a:gd name="connsiteX3" fmla="*/ 555754 w 563018"/>
              <a:gd name="connsiteY3" fmla="*/ 475103 h 475103"/>
              <a:gd name="connsiteX4" fmla="*/ 0 w 563018"/>
              <a:gd name="connsiteY4" fmla="*/ 475103 h 475103"/>
              <a:gd name="connsiteX0" fmla="*/ 0 w 563018"/>
              <a:gd name="connsiteY0" fmla="*/ 475103 h 486255"/>
              <a:gd name="connsiteX1" fmla="*/ 7264 w 563018"/>
              <a:gd name="connsiteY1" fmla="*/ 0 h 486255"/>
              <a:gd name="connsiteX2" fmla="*/ 563018 w 563018"/>
              <a:gd name="connsiteY2" fmla="*/ 0 h 486255"/>
              <a:gd name="connsiteX3" fmla="*/ 499998 w 563018"/>
              <a:gd name="connsiteY3" fmla="*/ 486255 h 486255"/>
              <a:gd name="connsiteX4" fmla="*/ 0 w 563018"/>
              <a:gd name="connsiteY4" fmla="*/ 475103 h 486255"/>
              <a:gd name="connsiteX0" fmla="*/ 0 w 585320"/>
              <a:gd name="connsiteY0" fmla="*/ 536435 h 547587"/>
              <a:gd name="connsiteX1" fmla="*/ 7264 w 585320"/>
              <a:gd name="connsiteY1" fmla="*/ 61332 h 547587"/>
              <a:gd name="connsiteX2" fmla="*/ 585320 w 585320"/>
              <a:gd name="connsiteY2" fmla="*/ 0 h 547587"/>
              <a:gd name="connsiteX3" fmla="*/ 499998 w 585320"/>
              <a:gd name="connsiteY3" fmla="*/ 547587 h 547587"/>
              <a:gd name="connsiteX4" fmla="*/ 0 w 585320"/>
              <a:gd name="connsiteY4" fmla="*/ 536435 h 54758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85320" h="547587">
                <a:moveTo>
                  <a:pt x="0" y="536435"/>
                </a:moveTo>
                <a:lnTo>
                  <a:pt x="7264" y="61332"/>
                </a:lnTo>
                <a:lnTo>
                  <a:pt x="585320" y="0"/>
                </a:lnTo>
                <a:lnTo>
                  <a:pt x="499998" y="547587"/>
                </a:lnTo>
                <a:lnTo>
                  <a:pt x="0" y="536435"/>
                </a:lnTo>
                <a:close/>
              </a:path>
            </a:pathLst>
          </a:custGeom>
          <a:solidFill>
            <a:schemeClr val="accent1">
              <a:lumMod val="20000"/>
              <a:lumOff val="80000"/>
              <a:alpha val="40000"/>
            </a:schemeClr>
          </a:solidFill>
          <a:ln w="6350">
            <a:solidFill>
              <a:schemeClr val="accent1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Parallelogram 97">
            <a:extLst>
              <a:ext uri="{FF2B5EF4-FFF2-40B4-BE49-F238E27FC236}">
                <a16:creationId xmlns:a16="http://schemas.microsoft.com/office/drawing/2014/main" id="{025A4DDB-2CB9-D748-8227-BF5E1E426D7E}"/>
              </a:ext>
            </a:extLst>
          </p:cNvPr>
          <p:cNvSpPr/>
          <p:nvPr/>
        </p:nvSpPr>
        <p:spPr>
          <a:xfrm>
            <a:off x="2992621" y="410060"/>
            <a:ext cx="244096" cy="515547"/>
          </a:xfrm>
          <a:custGeom>
            <a:avLst/>
            <a:gdLst>
              <a:gd name="connsiteX0" fmla="*/ 0 w 563018"/>
              <a:gd name="connsiteY0" fmla="*/ 475103 h 475103"/>
              <a:gd name="connsiteX1" fmla="*/ 7264 w 563018"/>
              <a:gd name="connsiteY1" fmla="*/ 0 h 475103"/>
              <a:gd name="connsiteX2" fmla="*/ 563018 w 563018"/>
              <a:gd name="connsiteY2" fmla="*/ 0 h 475103"/>
              <a:gd name="connsiteX3" fmla="*/ 555754 w 563018"/>
              <a:gd name="connsiteY3" fmla="*/ 475103 h 475103"/>
              <a:gd name="connsiteX4" fmla="*/ 0 w 563018"/>
              <a:gd name="connsiteY4" fmla="*/ 475103 h 475103"/>
              <a:gd name="connsiteX0" fmla="*/ 0 w 563018"/>
              <a:gd name="connsiteY0" fmla="*/ 475103 h 486255"/>
              <a:gd name="connsiteX1" fmla="*/ 7264 w 563018"/>
              <a:gd name="connsiteY1" fmla="*/ 0 h 486255"/>
              <a:gd name="connsiteX2" fmla="*/ 563018 w 563018"/>
              <a:gd name="connsiteY2" fmla="*/ 0 h 486255"/>
              <a:gd name="connsiteX3" fmla="*/ 499998 w 563018"/>
              <a:gd name="connsiteY3" fmla="*/ 486255 h 486255"/>
              <a:gd name="connsiteX4" fmla="*/ 0 w 563018"/>
              <a:gd name="connsiteY4" fmla="*/ 475103 h 486255"/>
              <a:gd name="connsiteX0" fmla="*/ 0 w 585320"/>
              <a:gd name="connsiteY0" fmla="*/ 536435 h 547587"/>
              <a:gd name="connsiteX1" fmla="*/ 7264 w 585320"/>
              <a:gd name="connsiteY1" fmla="*/ 61332 h 547587"/>
              <a:gd name="connsiteX2" fmla="*/ 585320 w 585320"/>
              <a:gd name="connsiteY2" fmla="*/ 0 h 547587"/>
              <a:gd name="connsiteX3" fmla="*/ 499998 w 585320"/>
              <a:gd name="connsiteY3" fmla="*/ 547587 h 547587"/>
              <a:gd name="connsiteX4" fmla="*/ 0 w 585320"/>
              <a:gd name="connsiteY4" fmla="*/ 536435 h 54758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85320" h="547587">
                <a:moveTo>
                  <a:pt x="0" y="536435"/>
                </a:moveTo>
                <a:lnTo>
                  <a:pt x="7264" y="61332"/>
                </a:lnTo>
                <a:lnTo>
                  <a:pt x="585320" y="0"/>
                </a:lnTo>
                <a:lnTo>
                  <a:pt x="499998" y="547587"/>
                </a:lnTo>
                <a:lnTo>
                  <a:pt x="0" y="536435"/>
                </a:lnTo>
                <a:close/>
              </a:path>
            </a:pathLst>
          </a:custGeom>
          <a:solidFill>
            <a:schemeClr val="accent1">
              <a:lumMod val="20000"/>
              <a:lumOff val="80000"/>
              <a:alpha val="40000"/>
            </a:schemeClr>
          </a:solidFill>
          <a:ln w="6350">
            <a:solidFill>
              <a:schemeClr val="accent1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Parallelogram 97">
            <a:extLst>
              <a:ext uri="{FF2B5EF4-FFF2-40B4-BE49-F238E27FC236}">
                <a16:creationId xmlns:a16="http://schemas.microsoft.com/office/drawing/2014/main" id="{13F8BBF7-F218-914B-A3D4-A2C272C2E22B}"/>
              </a:ext>
            </a:extLst>
          </p:cNvPr>
          <p:cNvSpPr/>
          <p:nvPr/>
        </p:nvSpPr>
        <p:spPr>
          <a:xfrm>
            <a:off x="2364200" y="440928"/>
            <a:ext cx="316383" cy="544583"/>
          </a:xfrm>
          <a:custGeom>
            <a:avLst/>
            <a:gdLst>
              <a:gd name="connsiteX0" fmla="*/ 0 w 563018"/>
              <a:gd name="connsiteY0" fmla="*/ 475103 h 475103"/>
              <a:gd name="connsiteX1" fmla="*/ 7264 w 563018"/>
              <a:gd name="connsiteY1" fmla="*/ 0 h 475103"/>
              <a:gd name="connsiteX2" fmla="*/ 563018 w 563018"/>
              <a:gd name="connsiteY2" fmla="*/ 0 h 475103"/>
              <a:gd name="connsiteX3" fmla="*/ 555754 w 563018"/>
              <a:gd name="connsiteY3" fmla="*/ 475103 h 475103"/>
              <a:gd name="connsiteX4" fmla="*/ 0 w 563018"/>
              <a:gd name="connsiteY4" fmla="*/ 475103 h 475103"/>
              <a:gd name="connsiteX0" fmla="*/ 0 w 563018"/>
              <a:gd name="connsiteY0" fmla="*/ 475103 h 486255"/>
              <a:gd name="connsiteX1" fmla="*/ 7264 w 563018"/>
              <a:gd name="connsiteY1" fmla="*/ 0 h 486255"/>
              <a:gd name="connsiteX2" fmla="*/ 563018 w 563018"/>
              <a:gd name="connsiteY2" fmla="*/ 0 h 486255"/>
              <a:gd name="connsiteX3" fmla="*/ 499998 w 563018"/>
              <a:gd name="connsiteY3" fmla="*/ 486255 h 486255"/>
              <a:gd name="connsiteX4" fmla="*/ 0 w 563018"/>
              <a:gd name="connsiteY4" fmla="*/ 475103 h 486255"/>
              <a:gd name="connsiteX0" fmla="*/ 0 w 585320"/>
              <a:gd name="connsiteY0" fmla="*/ 536435 h 547587"/>
              <a:gd name="connsiteX1" fmla="*/ 7264 w 585320"/>
              <a:gd name="connsiteY1" fmla="*/ 61332 h 547587"/>
              <a:gd name="connsiteX2" fmla="*/ 585320 w 585320"/>
              <a:gd name="connsiteY2" fmla="*/ 0 h 547587"/>
              <a:gd name="connsiteX3" fmla="*/ 499998 w 585320"/>
              <a:gd name="connsiteY3" fmla="*/ 547587 h 547587"/>
              <a:gd name="connsiteX4" fmla="*/ 0 w 585320"/>
              <a:gd name="connsiteY4" fmla="*/ 536435 h 54758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85320" h="547587">
                <a:moveTo>
                  <a:pt x="0" y="536435"/>
                </a:moveTo>
                <a:lnTo>
                  <a:pt x="7264" y="61332"/>
                </a:lnTo>
                <a:lnTo>
                  <a:pt x="585320" y="0"/>
                </a:lnTo>
                <a:lnTo>
                  <a:pt x="499998" y="547587"/>
                </a:lnTo>
                <a:lnTo>
                  <a:pt x="0" y="536435"/>
                </a:lnTo>
                <a:close/>
              </a:path>
            </a:pathLst>
          </a:custGeom>
          <a:solidFill>
            <a:schemeClr val="accent1">
              <a:lumMod val="20000"/>
              <a:lumOff val="80000"/>
              <a:alpha val="40000"/>
            </a:schemeClr>
          </a:solidFill>
          <a:ln w="6350">
            <a:solidFill>
              <a:schemeClr val="accent1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Parallelogram 97">
            <a:extLst>
              <a:ext uri="{FF2B5EF4-FFF2-40B4-BE49-F238E27FC236}">
                <a16:creationId xmlns:a16="http://schemas.microsoft.com/office/drawing/2014/main" id="{21B0EC80-7A6B-354D-8109-7F3F6EBDC55A}"/>
              </a:ext>
            </a:extLst>
          </p:cNvPr>
          <p:cNvSpPr/>
          <p:nvPr/>
        </p:nvSpPr>
        <p:spPr>
          <a:xfrm>
            <a:off x="2710973" y="457658"/>
            <a:ext cx="244096" cy="515547"/>
          </a:xfrm>
          <a:custGeom>
            <a:avLst/>
            <a:gdLst>
              <a:gd name="connsiteX0" fmla="*/ 0 w 563018"/>
              <a:gd name="connsiteY0" fmla="*/ 475103 h 475103"/>
              <a:gd name="connsiteX1" fmla="*/ 7264 w 563018"/>
              <a:gd name="connsiteY1" fmla="*/ 0 h 475103"/>
              <a:gd name="connsiteX2" fmla="*/ 563018 w 563018"/>
              <a:gd name="connsiteY2" fmla="*/ 0 h 475103"/>
              <a:gd name="connsiteX3" fmla="*/ 555754 w 563018"/>
              <a:gd name="connsiteY3" fmla="*/ 475103 h 475103"/>
              <a:gd name="connsiteX4" fmla="*/ 0 w 563018"/>
              <a:gd name="connsiteY4" fmla="*/ 475103 h 475103"/>
              <a:gd name="connsiteX0" fmla="*/ 0 w 563018"/>
              <a:gd name="connsiteY0" fmla="*/ 475103 h 486255"/>
              <a:gd name="connsiteX1" fmla="*/ 7264 w 563018"/>
              <a:gd name="connsiteY1" fmla="*/ 0 h 486255"/>
              <a:gd name="connsiteX2" fmla="*/ 563018 w 563018"/>
              <a:gd name="connsiteY2" fmla="*/ 0 h 486255"/>
              <a:gd name="connsiteX3" fmla="*/ 499998 w 563018"/>
              <a:gd name="connsiteY3" fmla="*/ 486255 h 486255"/>
              <a:gd name="connsiteX4" fmla="*/ 0 w 563018"/>
              <a:gd name="connsiteY4" fmla="*/ 475103 h 486255"/>
              <a:gd name="connsiteX0" fmla="*/ 0 w 585320"/>
              <a:gd name="connsiteY0" fmla="*/ 536435 h 547587"/>
              <a:gd name="connsiteX1" fmla="*/ 7264 w 585320"/>
              <a:gd name="connsiteY1" fmla="*/ 61332 h 547587"/>
              <a:gd name="connsiteX2" fmla="*/ 585320 w 585320"/>
              <a:gd name="connsiteY2" fmla="*/ 0 h 547587"/>
              <a:gd name="connsiteX3" fmla="*/ 499998 w 585320"/>
              <a:gd name="connsiteY3" fmla="*/ 547587 h 547587"/>
              <a:gd name="connsiteX4" fmla="*/ 0 w 585320"/>
              <a:gd name="connsiteY4" fmla="*/ 536435 h 54758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85320" h="547587">
                <a:moveTo>
                  <a:pt x="0" y="536435"/>
                </a:moveTo>
                <a:lnTo>
                  <a:pt x="7264" y="61332"/>
                </a:lnTo>
                <a:lnTo>
                  <a:pt x="585320" y="0"/>
                </a:lnTo>
                <a:lnTo>
                  <a:pt x="499998" y="547587"/>
                </a:lnTo>
                <a:lnTo>
                  <a:pt x="0" y="536435"/>
                </a:lnTo>
                <a:close/>
              </a:path>
            </a:pathLst>
          </a:custGeom>
          <a:solidFill>
            <a:schemeClr val="accent1">
              <a:lumMod val="20000"/>
              <a:lumOff val="80000"/>
              <a:alpha val="40000"/>
            </a:schemeClr>
          </a:solidFill>
          <a:ln w="6350">
            <a:solidFill>
              <a:schemeClr val="accent1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0" name="Parallelogram 97">
            <a:extLst>
              <a:ext uri="{FF2B5EF4-FFF2-40B4-BE49-F238E27FC236}">
                <a16:creationId xmlns:a16="http://schemas.microsoft.com/office/drawing/2014/main" id="{863FFF4A-0CC7-1049-9A4E-FFF1E73100D0}"/>
              </a:ext>
            </a:extLst>
          </p:cNvPr>
          <p:cNvSpPr/>
          <p:nvPr/>
        </p:nvSpPr>
        <p:spPr>
          <a:xfrm>
            <a:off x="2099889" y="445844"/>
            <a:ext cx="244096" cy="515547"/>
          </a:xfrm>
          <a:custGeom>
            <a:avLst/>
            <a:gdLst>
              <a:gd name="connsiteX0" fmla="*/ 0 w 563018"/>
              <a:gd name="connsiteY0" fmla="*/ 475103 h 475103"/>
              <a:gd name="connsiteX1" fmla="*/ 7264 w 563018"/>
              <a:gd name="connsiteY1" fmla="*/ 0 h 475103"/>
              <a:gd name="connsiteX2" fmla="*/ 563018 w 563018"/>
              <a:gd name="connsiteY2" fmla="*/ 0 h 475103"/>
              <a:gd name="connsiteX3" fmla="*/ 555754 w 563018"/>
              <a:gd name="connsiteY3" fmla="*/ 475103 h 475103"/>
              <a:gd name="connsiteX4" fmla="*/ 0 w 563018"/>
              <a:gd name="connsiteY4" fmla="*/ 475103 h 475103"/>
              <a:gd name="connsiteX0" fmla="*/ 0 w 563018"/>
              <a:gd name="connsiteY0" fmla="*/ 475103 h 486255"/>
              <a:gd name="connsiteX1" fmla="*/ 7264 w 563018"/>
              <a:gd name="connsiteY1" fmla="*/ 0 h 486255"/>
              <a:gd name="connsiteX2" fmla="*/ 563018 w 563018"/>
              <a:gd name="connsiteY2" fmla="*/ 0 h 486255"/>
              <a:gd name="connsiteX3" fmla="*/ 499998 w 563018"/>
              <a:gd name="connsiteY3" fmla="*/ 486255 h 486255"/>
              <a:gd name="connsiteX4" fmla="*/ 0 w 563018"/>
              <a:gd name="connsiteY4" fmla="*/ 475103 h 486255"/>
              <a:gd name="connsiteX0" fmla="*/ 0 w 585320"/>
              <a:gd name="connsiteY0" fmla="*/ 536435 h 547587"/>
              <a:gd name="connsiteX1" fmla="*/ 7264 w 585320"/>
              <a:gd name="connsiteY1" fmla="*/ 61332 h 547587"/>
              <a:gd name="connsiteX2" fmla="*/ 585320 w 585320"/>
              <a:gd name="connsiteY2" fmla="*/ 0 h 547587"/>
              <a:gd name="connsiteX3" fmla="*/ 499998 w 585320"/>
              <a:gd name="connsiteY3" fmla="*/ 547587 h 547587"/>
              <a:gd name="connsiteX4" fmla="*/ 0 w 585320"/>
              <a:gd name="connsiteY4" fmla="*/ 536435 h 54758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85320" h="547587">
                <a:moveTo>
                  <a:pt x="0" y="536435"/>
                </a:moveTo>
                <a:lnTo>
                  <a:pt x="7264" y="61332"/>
                </a:lnTo>
                <a:lnTo>
                  <a:pt x="585320" y="0"/>
                </a:lnTo>
                <a:lnTo>
                  <a:pt x="499998" y="547587"/>
                </a:lnTo>
                <a:lnTo>
                  <a:pt x="0" y="536435"/>
                </a:lnTo>
                <a:close/>
              </a:path>
            </a:pathLst>
          </a:custGeom>
          <a:solidFill>
            <a:schemeClr val="accent1">
              <a:lumMod val="20000"/>
              <a:lumOff val="80000"/>
              <a:alpha val="40000"/>
            </a:schemeClr>
          </a:solidFill>
          <a:ln w="6350">
            <a:solidFill>
              <a:schemeClr val="accent1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9" name="Parallelogram 97">
            <a:extLst>
              <a:ext uri="{FF2B5EF4-FFF2-40B4-BE49-F238E27FC236}">
                <a16:creationId xmlns:a16="http://schemas.microsoft.com/office/drawing/2014/main" id="{B15BEA6F-B338-C548-9FBE-A8897B0C6941}"/>
              </a:ext>
            </a:extLst>
          </p:cNvPr>
          <p:cNvSpPr/>
          <p:nvPr/>
        </p:nvSpPr>
        <p:spPr>
          <a:xfrm>
            <a:off x="1741017" y="437924"/>
            <a:ext cx="342124" cy="561176"/>
          </a:xfrm>
          <a:custGeom>
            <a:avLst/>
            <a:gdLst>
              <a:gd name="connsiteX0" fmla="*/ 0 w 563018"/>
              <a:gd name="connsiteY0" fmla="*/ 475103 h 475103"/>
              <a:gd name="connsiteX1" fmla="*/ 7264 w 563018"/>
              <a:gd name="connsiteY1" fmla="*/ 0 h 475103"/>
              <a:gd name="connsiteX2" fmla="*/ 563018 w 563018"/>
              <a:gd name="connsiteY2" fmla="*/ 0 h 475103"/>
              <a:gd name="connsiteX3" fmla="*/ 555754 w 563018"/>
              <a:gd name="connsiteY3" fmla="*/ 475103 h 475103"/>
              <a:gd name="connsiteX4" fmla="*/ 0 w 563018"/>
              <a:gd name="connsiteY4" fmla="*/ 475103 h 475103"/>
              <a:gd name="connsiteX0" fmla="*/ 0 w 563018"/>
              <a:gd name="connsiteY0" fmla="*/ 475103 h 486255"/>
              <a:gd name="connsiteX1" fmla="*/ 7264 w 563018"/>
              <a:gd name="connsiteY1" fmla="*/ 0 h 486255"/>
              <a:gd name="connsiteX2" fmla="*/ 563018 w 563018"/>
              <a:gd name="connsiteY2" fmla="*/ 0 h 486255"/>
              <a:gd name="connsiteX3" fmla="*/ 499998 w 563018"/>
              <a:gd name="connsiteY3" fmla="*/ 486255 h 486255"/>
              <a:gd name="connsiteX4" fmla="*/ 0 w 563018"/>
              <a:gd name="connsiteY4" fmla="*/ 475103 h 486255"/>
              <a:gd name="connsiteX0" fmla="*/ 0 w 585320"/>
              <a:gd name="connsiteY0" fmla="*/ 536435 h 547587"/>
              <a:gd name="connsiteX1" fmla="*/ 7264 w 585320"/>
              <a:gd name="connsiteY1" fmla="*/ 61332 h 547587"/>
              <a:gd name="connsiteX2" fmla="*/ 585320 w 585320"/>
              <a:gd name="connsiteY2" fmla="*/ 0 h 547587"/>
              <a:gd name="connsiteX3" fmla="*/ 499998 w 585320"/>
              <a:gd name="connsiteY3" fmla="*/ 547587 h 547587"/>
              <a:gd name="connsiteX4" fmla="*/ 0 w 585320"/>
              <a:gd name="connsiteY4" fmla="*/ 536435 h 54758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85320" h="547587">
                <a:moveTo>
                  <a:pt x="0" y="536435"/>
                </a:moveTo>
                <a:lnTo>
                  <a:pt x="7264" y="61332"/>
                </a:lnTo>
                <a:lnTo>
                  <a:pt x="585320" y="0"/>
                </a:lnTo>
                <a:lnTo>
                  <a:pt x="499998" y="547587"/>
                </a:lnTo>
                <a:lnTo>
                  <a:pt x="0" y="536435"/>
                </a:lnTo>
                <a:close/>
              </a:path>
            </a:pathLst>
          </a:custGeom>
          <a:solidFill>
            <a:schemeClr val="accent1">
              <a:lumMod val="20000"/>
              <a:lumOff val="80000"/>
              <a:alpha val="40000"/>
            </a:schemeClr>
          </a:solidFill>
          <a:ln w="6350">
            <a:solidFill>
              <a:schemeClr val="accent1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8" name="Parallelogram 97">
            <a:extLst>
              <a:ext uri="{FF2B5EF4-FFF2-40B4-BE49-F238E27FC236}">
                <a16:creationId xmlns:a16="http://schemas.microsoft.com/office/drawing/2014/main" id="{652E6CF0-FC17-8E4D-B633-6C794128AAF4}"/>
              </a:ext>
            </a:extLst>
          </p:cNvPr>
          <p:cNvSpPr/>
          <p:nvPr/>
        </p:nvSpPr>
        <p:spPr>
          <a:xfrm>
            <a:off x="1137548" y="437924"/>
            <a:ext cx="585320" cy="547587"/>
          </a:xfrm>
          <a:custGeom>
            <a:avLst/>
            <a:gdLst>
              <a:gd name="connsiteX0" fmla="*/ 0 w 563018"/>
              <a:gd name="connsiteY0" fmla="*/ 475103 h 475103"/>
              <a:gd name="connsiteX1" fmla="*/ 7264 w 563018"/>
              <a:gd name="connsiteY1" fmla="*/ 0 h 475103"/>
              <a:gd name="connsiteX2" fmla="*/ 563018 w 563018"/>
              <a:gd name="connsiteY2" fmla="*/ 0 h 475103"/>
              <a:gd name="connsiteX3" fmla="*/ 555754 w 563018"/>
              <a:gd name="connsiteY3" fmla="*/ 475103 h 475103"/>
              <a:gd name="connsiteX4" fmla="*/ 0 w 563018"/>
              <a:gd name="connsiteY4" fmla="*/ 475103 h 475103"/>
              <a:gd name="connsiteX0" fmla="*/ 0 w 563018"/>
              <a:gd name="connsiteY0" fmla="*/ 475103 h 486255"/>
              <a:gd name="connsiteX1" fmla="*/ 7264 w 563018"/>
              <a:gd name="connsiteY1" fmla="*/ 0 h 486255"/>
              <a:gd name="connsiteX2" fmla="*/ 563018 w 563018"/>
              <a:gd name="connsiteY2" fmla="*/ 0 h 486255"/>
              <a:gd name="connsiteX3" fmla="*/ 499998 w 563018"/>
              <a:gd name="connsiteY3" fmla="*/ 486255 h 486255"/>
              <a:gd name="connsiteX4" fmla="*/ 0 w 563018"/>
              <a:gd name="connsiteY4" fmla="*/ 475103 h 486255"/>
              <a:gd name="connsiteX0" fmla="*/ 0 w 585320"/>
              <a:gd name="connsiteY0" fmla="*/ 536435 h 547587"/>
              <a:gd name="connsiteX1" fmla="*/ 7264 w 585320"/>
              <a:gd name="connsiteY1" fmla="*/ 61332 h 547587"/>
              <a:gd name="connsiteX2" fmla="*/ 585320 w 585320"/>
              <a:gd name="connsiteY2" fmla="*/ 0 h 547587"/>
              <a:gd name="connsiteX3" fmla="*/ 499998 w 585320"/>
              <a:gd name="connsiteY3" fmla="*/ 547587 h 547587"/>
              <a:gd name="connsiteX4" fmla="*/ 0 w 585320"/>
              <a:gd name="connsiteY4" fmla="*/ 536435 h 54758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85320" h="547587">
                <a:moveTo>
                  <a:pt x="0" y="536435"/>
                </a:moveTo>
                <a:lnTo>
                  <a:pt x="7264" y="61332"/>
                </a:lnTo>
                <a:lnTo>
                  <a:pt x="585320" y="0"/>
                </a:lnTo>
                <a:lnTo>
                  <a:pt x="499998" y="547587"/>
                </a:lnTo>
                <a:lnTo>
                  <a:pt x="0" y="536435"/>
                </a:lnTo>
                <a:close/>
              </a:path>
            </a:pathLst>
          </a:custGeom>
          <a:solidFill>
            <a:schemeClr val="accent1">
              <a:lumMod val="20000"/>
              <a:lumOff val="80000"/>
              <a:alpha val="40000"/>
            </a:schemeClr>
          </a:solidFill>
          <a:ln w="6350">
            <a:solidFill>
              <a:schemeClr val="accent1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5ADA73F-8E21-4648-B946-848C3DFF0CC2}"/>
              </a:ext>
            </a:extLst>
          </p:cNvPr>
          <p:cNvSpPr txBox="1"/>
          <p:nvPr/>
        </p:nvSpPr>
        <p:spPr>
          <a:xfrm>
            <a:off x="-47497" y="290935"/>
            <a:ext cx="13372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cs typeface="Arial" panose="020B0604020202020204" pitchFamily="34" charset="0"/>
              </a:rPr>
              <a:t>C. acnes </a:t>
            </a:r>
            <a:r>
              <a:rPr lang="en-US" sz="1100" dirty="0">
                <a:cs typeface="Arial" panose="020B0604020202020204" pitchFamily="34" charset="0"/>
              </a:rPr>
              <a:t>HL110PA4 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D15CBB97-3E80-E24D-B424-B47B9618DF25}"/>
              </a:ext>
            </a:extLst>
          </p:cNvPr>
          <p:cNvCxnSpPr>
            <a:cxnSpLocks/>
          </p:cNvCxnSpPr>
          <p:nvPr/>
        </p:nvCxnSpPr>
        <p:spPr>
          <a:xfrm flipV="1">
            <a:off x="1291816" y="420875"/>
            <a:ext cx="2769235" cy="6331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Pentagon 10">
            <a:extLst>
              <a:ext uri="{FF2B5EF4-FFF2-40B4-BE49-F238E27FC236}">
                <a16:creationId xmlns:a16="http://schemas.microsoft.com/office/drawing/2014/main" id="{151A8F86-6E9B-CB41-9983-F670E6FBE036}"/>
              </a:ext>
            </a:extLst>
          </p:cNvPr>
          <p:cNvSpPr/>
          <p:nvPr/>
        </p:nvSpPr>
        <p:spPr>
          <a:xfrm>
            <a:off x="2996497" y="342264"/>
            <a:ext cx="268333" cy="158951"/>
          </a:xfrm>
          <a:prstGeom prst="homePlate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 dirty="0">
              <a:solidFill>
                <a:schemeClr val="tx1"/>
              </a:solidFill>
            </a:endParaRPr>
          </a:p>
        </p:txBody>
      </p:sp>
      <p:sp>
        <p:nvSpPr>
          <p:cNvPr id="12" name="Pentagon 11">
            <a:extLst>
              <a:ext uri="{FF2B5EF4-FFF2-40B4-BE49-F238E27FC236}">
                <a16:creationId xmlns:a16="http://schemas.microsoft.com/office/drawing/2014/main" id="{BF0981C4-F285-514F-858A-BAB6D1F7012D}"/>
              </a:ext>
            </a:extLst>
          </p:cNvPr>
          <p:cNvSpPr/>
          <p:nvPr/>
        </p:nvSpPr>
        <p:spPr>
          <a:xfrm>
            <a:off x="2712345" y="342264"/>
            <a:ext cx="276867" cy="158951"/>
          </a:xfrm>
          <a:prstGeom prst="homePlate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 dirty="0">
              <a:solidFill>
                <a:schemeClr val="tx1"/>
              </a:solidFill>
            </a:endParaRPr>
          </a:p>
        </p:txBody>
      </p:sp>
      <p:sp>
        <p:nvSpPr>
          <p:cNvPr id="13" name="Pentagon 12">
            <a:extLst>
              <a:ext uri="{FF2B5EF4-FFF2-40B4-BE49-F238E27FC236}">
                <a16:creationId xmlns:a16="http://schemas.microsoft.com/office/drawing/2014/main" id="{5C686AA6-019F-7441-9B66-E0251238DDFA}"/>
              </a:ext>
            </a:extLst>
          </p:cNvPr>
          <p:cNvSpPr/>
          <p:nvPr/>
        </p:nvSpPr>
        <p:spPr>
          <a:xfrm>
            <a:off x="1740714" y="342264"/>
            <a:ext cx="360067" cy="158951"/>
          </a:xfrm>
          <a:prstGeom prst="homePlate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 dirty="0">
              <a:solidFill>
                <a:schemeClr val="tx1"/>
              </a:solidFill>
            </a:endParaRPr>
          </a:p>
        </p:txBody>
      </p:sp>
      <p:sp>
        <p:nvSpPr>
          <p:cNvPr id="14" name="Pentagon 13">
            <a:extLst>
              <a:ext uri="{FF2B5EF4-FFF2-40B4-BE49-F238E27FC236}">
                <a16:creationId xmlns:a16="http://schemas.microsoft.com/office/drawing/2014/main" id="{65EE7C70-CF05-ED4D-9D82-87401A877279}"/>
              </a:ext>
            </a:extLst>
          </p:cNvPr>
          <p:cNvSpPr/>
          <p:nvPr/>
        </p:nvSpPr>
        <p:spPr>
          <a:xfrm>
            <a:off x="2358926" y="342264"/>
            <a:ext cx="339918" cy="158951"/>
          </a:xfrm>
          <a:prstGeom prst="homePlate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 dirty="0">
              <a:solidFill>
                <a:schemeClr val="tx1"/>
              </a:solidFill>
            </a:endParaRPr>
          </a:p>
        </p:txBody>
      </p:sp>
      <p:sp>
        <p:nvSpPr>
          <p:cNvPr id="15" name="Pentagon 14">
            <a:extLst>
              <a:ext uri="{FF2B5EF4-FFF2-40B4-BE49-F238E27FC236}">
                <a16:creationId xmlns:a16="http://schemas.microsoft.com/office/drawing/2014/main" id="{DFB8FE01-3646-BF45-88F3-02BF2A563700}"/>
              </a:ext>
            </a:extLst>
          </p:cNvPr>
          <p:cNvSpPr/>
          <p:nvPr/>
        </p:nvSpPr>
        <p:spPr>
          <a:xfrm>
            <a:off x="2101439" y="342264"/>
            <a:ext cx="249261" cy="158951"/>
          </a:xfrm>
          <a:prstGeom prst="homePlate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 dirty="0">
              <a:solidFill>
                <a:schemeClr val="tx1"/>
              </a:solidFill>
            </a:endParaRPr>
          </a:p>
        </p:txBody>
      </p:sp>
      <p:sp>
        <p:nvSpPr>
          <p:cNvPr id="16" name="Pentagon 15">
            <a:extLst>
              <a:ext uri="{FF2B5EF4-FFF2-40B4-BE49-F238E27FC236}">
                <a16:creationId xmlns:a16="http://schemas.microsoft.com/office/drawing/2014/main" id="{A5D067E4-C9A0-BD4F-926A-92B78238819D}"/>
              </a:ext>
            </a:extLst>
          </p:cNvPr>
          <p:cNvSpPr/>
          <p:nvPr/>
        </p:nvSpPr>
        <p:spPr>
          <a:xfrm>
            <a:off x="3279772" y="342264"/>
            <a:ext cx="274816" cy="158951"/>
          </a:xfrm>
          <a:prstGeom prst="homePlate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 dirty="0">
              <a:solidFill>
                <a:schemeClr val="tx1"/>
              </a:solidFill>
            </a:endParaRPr>
          </a:p>
        </p:txBody>
      </p:sp>
      <p:sp>
        <p:nvSpPr>
          <p:cNvPr id="17" name="Pentagon 16">
            <a:extLst>
              <a:ext uri="{FF2B5EF4-FFF2-40B4-BE49-F238E27FC236}">
                <a16:creationId xmlns:a16="http://schemas.microsoft.com/office/drawing/2014/main" id="{152EC3D8-943D-C34B-8C50-BB603D46266F}"/>
              </a:ext>
            </a:extLst>
          </p:cNvPr>
          <p:cNvSpPr/>
          <p:nvPr/>
        </p:nvSpPr>
        <p:spPr>
          <a:xfrm>
            <a:off x="3628254" y="342264"/>
            <a:ext cx="244236" cy="158951"/>
          </a:xfrm>
          <a:prstGeom prst="homePlate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 dirty="0">
              <a:solidFill>
                <a:schemeClr val="tx1"/>
              </a:solidFill>
            </a:endParaRPr>
          </a:p>
        </p:txBody>
      </p:sp>
      <p:sp>
        <p:nvSpPr>
          <p:cNvPr id="18" name="Pentagon 17">
            <a:extLst>
              <a:ext uri="{FF2B5EF4-FFF2-40B4-BE49-F238E27FC236}">
                <a16:creationId xmlns:a16="http://schemas.microsoft.com/office/drawing/2014/main" id="{4DFBECF0-1B7A-CB42-8F49-5A17A86FDF12}"/>
              </a:ext>
            </a:extLst>
          </p:cNvPr>
          <p:cNvSpPr/>
          <p:nvPr/>
        </p:nvSpPr>
        <p:spPr>
          <a:xfrm>
            <a:off x="1138206" y="342264"/>
            <a:ext cx="595867" cy="158951"/>
          </a:xfrm>
          <a:prstGeom prst="homePlate">
            <a:avLst/>
          </a:prstGeom>
          <a:solidFill>
            <a:schemeClr val="accent5">
              <a:lumMod val="40000"/>
              <a:lumOff val="60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 dirty="0">
              <a:solidFill>
                <a:schemeClr val="tx1"/>
              </a:solidFill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05047ACD-E498-4C4B-BE5F-7A1ED4BA461E}"/>
              </a:ext>
            </a:extLst>
          </p:cNvPr>
          <p:cNvSpPr/>
          <p:nvPr/>
        </p:nvSpPr>
        <p:spPr>
          <a:xfrm>
            <a:off x="3951019" y="374061"/>
            <a:ext cx="56819" cy="87122"/>
          </a:xfrm>
          <a:prstGeom prst="rect">
            <a:avLst/>
          </a:prstGeom>
          <a:solidFill>
            <a:schemeClr val="bg1">
              <a:lumMod val="8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Diamond 19">
            <a:extLst>
              <a:ext uri="{FF2B5EF4-FFF2-40B4-BE49-F238E27FC236}">
                <a16:creationId xmlns:a16="http://schemas.microsoft.com/office/drawing/2014/main" id="{D36FD8E7-295A-7F4C-9119-84CA04D9DA3C}"/>
              </a:ext>
            </a:extLst>
          </p:cNvPr>
          <p:cNvSpPr/>
          <p:nvPr/>
        </p:nvSpPr>
        <p:spPr>
          <a:xfrm>
            <a:off x="3891657" y="345021"/>
            <a:ext cx="45720" cy="137160"/>
          </a:xfrm>
          <a:prstGeom prst="diamond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B141E0C-7B47-1E4D-B790-626783F4C808}"/>
              </a:ext>
            </a:extLst>
          </p:cNvPr>
          <p:cNvSpPr txBox="1"/>
          <p:nvPr/>
        </p:nvSpPr>
        <p:spPr>
          <a:xfrm>
            <a:off x="1239406" y="330383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i="1" dirty="0">
                <a:latin typeface="Arial" panose="020B0604020202020204" pitchFamily="34" charset="0"/>
                <a:cs typeface="Arial" panose="020B0604020202020204" pitchFamily="34" charset="0"/>
              </a:rPr>
              <a:t>cas3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4FC26DD-009A-3347-8F47-46B2C7449421}"/>
              </a:ext>
            </a:extLst>
          </p:cNvPr>
          <p:cNvSpPr txBox="1"/>
          <p:nvPr/>
        </p:nvSpPr>
        <p:spPr>
          <a:xfrm>
            <a:off x="1722840" y="328542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i="1" dirty="0">
                <a:latin typeface="Arial" panose="020B0604020202020204" pitchFamily="34" charset="0"/>
                <a:cs typeface="Arial" panose="020B0604020202020204" pitchFamily="34" charset="0"/>
              </a:rPr>
              <a:t>cas8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C6A5722-FE95-A847-92E4-56BC088B1CAB}"/>
              </a:ext>
            </a:extLst>
          </p:cNvPr>
          <p:cNvSpPr txBox="1"/>
          <p:nvPr/>
        </p:nvSpPr>
        <p:spPr>
          <a:xfrm>
            <a:off x="2024493" y="328542"/>
            <a:ext cx="3914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i="1" dirty="0">
                <a:latin typeface="Arial" panose="020B0604020202020204" pitchFamily="34" charset="0"/>
                <a:cs typeface="Arial" panose="020B0604020202020204" pitchFamily="34" charset="0"/>
              </a:rPr>
              <a:t>cas1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6A64B3D-7038-B140-86DF-60BDE853E173}"/>
              </a:ext>
            </a:extLst>
          </p:cNvPr>
          <p:cNvSpPr txBox="1"/>
          <p:nvPr/>
        </p:nvSpPr>
        <p:spPr>
          <a:xfrm>
            <a:off x="2342709" y="328542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i="1" dirty="0">
                <a:latin typeface="Arial" panose="020B0604020202020204" pitchFamily="34" charset="0"/>
                <a:cs typeface="Arial" panose="020B0604020202020204" pitchFamily="34" charset="0"/>
              </a:rPr>
              <a:t>cas7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E35B4D7-A607-634D-88F3-94608838D772}"/>
              </a:ext>
            </a:extLst>
          </p:cNvPr>
          <p:cNvSpPr txBox="1"/>
          <p:nvPr/>
        </p:nvSpPr>
        <p:spPr>
          <a:xfrm>
            <a:off x="2942492" y="328542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i="1" dirty="0">
                <a:latin typeface="Arial" panose="020B0604020202020204" pitchFamily="34" charset="0"/>
                <a:cs typeface="Arial" panose="020B0604020202020204" pitchFamily="34" charset="0"/>
              </a:rPr>
              <a:t>cas6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86B4801-26DB-6E46-8BA9-E4B6532121B5}"/>
              </a:ext>
            </a:extLst>
          </p:cNvPr>
          <p:cNvSpPr txBox="1"/>
          <p:nvPr/>
        </p:nvSpPr>
        <p:spPr>
          <a:xfrm>
            <a:off x="2653327" y="328542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i="1" dirty="0">
                <a:latin typeface="Arial" panose="020B0604020202020204" pitchFamily="34" charset="0"/>
                <a:cs typeface="Arial" panose="020B0604020202020204" pitchFamily="34" charset="0"/>
              </a:rPr>
              <a:t>cas5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01B8E75-E550-6147-8928-DB96687D4A98}"/>
              </a:ext>
            </a:extLst>
          </p:cNvPr>
          <p:cNvSpPr txBox="1"/>
          <p:nvPr/>
        </p:nvSpPr>
        <p:spPr>
          <a:xfrm>
            <a:off x="3250359" y="325841"/>
            <a:ext cx="35590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i="1" dirty="0">
                <a:latin typeface="Arial" panose="020B0604020202020204" pitchFamily="34" charset="0"/>
                <a:cs typeface="Arial" panose="020B0604020202020204" pitchFamily="34" charset="0"/>
              </a:rPr>
              <a:t>cas1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7CD35E7-668A-0346-8CB9-BBF0556E5A27}"/>
              </a:ext>
            </a:extLst>
          </p:cNvPr>
          <p:cNvSpPr txBox="1"/>
          <p:nvPr/>
        </p:nvSpPr>
        <p:spPr>
          <a:xfrm>
            <a:off x="3563170" y="328542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i="1" dirty="0">
                <a:latin typeface="Arial" panose="020B0604020202020204" pitchFamily="34" charset="0"/>
                <a:cs typeface="Arial" panose="020B0604020202020204" pitchFamily="34" charset="0"/>
              </a:rPr>
              <a:t>cas2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C5F4461-801E-8541-8D55-7AFBB518AF79}"/>
              </a:ext>
            </a:extLst>
          </p:cNvPr>
          <p:cNvSpPr txBox="1"/>
          <p:nvPr/>
        </p:nvSpPr>
        <p:spPr>
          <a:xfrm>
            <a:off x="-47497" y="-47997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</a:t>
            </a:r>
          </a:p>
        </p:txBody>
      </p:sp>
      <p:sp>
        <p:nvSpPr>
          <p:cNvPr id="48" name="Diamond 47">
            <a:extLst>
              <a:ext uri="{FF2B5EF4-FFF2-40B4-BE49-F238E27FC236}">
                <a16:creationId xmlns:a16="http://schemas.microsoft.com/office/drawing/2014/main" id="{515D8890-7B6B-814A-8FDB-99E545A81B97}"/>
              </a:ext>
            </a:extLst>
          </p:cNvPr>
          <p:cNvSpPr/>
          <p:nvPr/>
        </p:nvSpPr>
        <p:spPr>
          <a:xfrm>
            <a:off x="4015331" y="345021"/>
            <a:ext cx="45720" cy="137160"/>
          </a:xfrm>
          <a:prstGeom prst="diamond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DFB26814-05A6-F540-BF63-E6FB0B5D0FA1}"/>
              </a:ext>
            </a:extLst>
          </p:cNvPr>
          <p:cNvSpPr txBox="1"/>
          <p:nvPr/>
        </p:nvSpPr>
        <p:spPr>
          <a:xfrm>
            <a:off x="451082" y="855909"/>
            <a:ext cx="7665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cs typeface="Arial" panose="020B0604020202020204" pitchFamily="34" charset="0"/>
              </a:rPr>
              <a:t>E. coli </a:t>
            </a:r>
            <a:r>
              <a:rPr lang="en-US" sz="1100" dirty="0">
                <a:cs typeface="Arial" panose="020B0604020202020204" pitchFamily="34" charset="0"/>
              </a:rPr>
              <a:t>K12</a:t>
            </a: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A0CAED77-79E8-6041-81E9-F32CA56DB117}"/>
              </a:ext>
            </a:extLst>
          </p:cNvPr>
          <p:cNvCxnSpPr>
            <a:cxnSpLocks/>
          </p:cNvCxnSpPr>
          <p:nvPr/>
        </p:nvCxnSpPr>
        <p:spPr>
          <a:xfrm flipV="1">
            <a:off x="1291816" y="980066"/>
            <a:ext cx="2769235" cy="13604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Pentagon 51">
            <a:extLst>
              <a:ext uri="{FF2B5EF4-FFF2-40B4-BE49-F238E27FC236}">
                <a16:creationId xmlns:a16="http://schemas.microsoft.com/office/drawing/2014/main" id="{0B1D76D1-A60C-2347-AA97-C7FBAF8B9C15}"/>
              </a:ext>
            </a:extLst>
          </p:cNvPr>
          <p:cNvSpPr/>
          <p:nvPr/>
        </p:nvSpPr>
        <p:spPr>
          <a:xfrm>
            <a:off x="2996497" y="908729"/>
            <a:ext cx="268333" cy="158951"/>
          </a:xfrm>
          <a:prstGeom prst="homePlate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 dirty="0">
              <a:solidFill>
                <a:schemeClr val="tx1"/>
              </a:solidFill>
            </a:endParaRPr>
          </a:p>
        </p:txBody>
      </p:sp>
      <p:sp>
        <p:nvSpPr>
          <p:cNvPr id="53" name="Pentagon 52">
            <a:extLst>
              <a:ext uri="{FF2B5EF4-FFF2-40B4-BE49-F238E27FC236}">
                <a16:creationId xmlns:a16="http://schemas.microsoft.com/office/drawing/2014/main" id="{8F0BA6B2-F744-AE47-A3E2-F9128947B51D}"/>
              </a:ext>
            </a:extLst>
          </p:cNvPr>
          <p:cNvSpPr/>
          <p:nvPr/>
        </p:nvSpPr>
        <p:spPr>
          <a:xfrm>
            <a:off x="2712345" y="908729"/>
            <a:ext cx="276867" cy="158951"/>
          </a:xfrm>
          <a:prstGeom prst="homePlate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 dirty="0">
              <a:solidFill>
                <a:schemeClr val="tx1"/>
              </a:solidFill>
            </a:endParaRPr>
          </a:p>
        </p:txBody>
      </p:sp>
      <p:sp>
        <p:nvSpPr>
          <p:cNvPr id="54" name="Pentagon 53">
            <a:extLst>
              <a:ext uri="{FF2B5EF4-FFF2-40B4-BE49-F238E27FC236}">
                <a16:creationId xmlns:a16="http://schemas.microsoft.com/office/drawing/2014/main" id="{09BB5A84-736F-0844-9ECE-E20675AC9C3D}"/>
              </a:ext>
            </a:extLst>
          </p:cNvPr>
          <p:cNvSpPr/>
          <p:nvPr/>
        </p:nvSpPr>
        <p:spPr>
          <a:xfrm>
            <a:off x="1740714" y="908729"/>
            <a:ext cx="299011" cy="158951"/>
          </a:xfrm>
          <a:prstGeom prst="homePlate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 dirty="0">
              <a:solidFill>
                <a:schemeClr val="tx1"/>
              </a:solidFill>
            </a:endParaRPr>
          </a:p>
        </p:txBody>
      </p:sp>
      <p:sp>
        <p:nvSpPr>
          <p:cNvPr id="55" name="Pentagon 54">
            <a:extLst>
              <a:ext uri="{FF2B5EF4-FFF2-40B4-BE49-F238E27FC236}">
                <a16:creationId xmlns:a16="http://schemas.microsoft.com/office/drawing/2014/main" id="{8E374FDB-39AC-DF45-944A-17F41C12FB11}"/>
              </a:ext>
            </a:extLst>
          </p:cNvPr>
          <p:cNvSpPr/>
          <p:nvPr/>
        </p:nvSpPr>
        <p:spPr>
          <a:xfrm>
            <a:off x="2358926" y="908729"/>
            <a:ext cx="339918" cy="158951"/>
          </a:xfrm>
          <a:prstGeom prst="homePlate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 dirty="0">
              <a:solidFill>
                <a:schemeClr val="tx1"/>
              </a:solidFill>
            </a:endParaRPr>
          </a:p>
        </p:txBody>
      </p:sp>
      <p:sp>
        <p:nvSpPr>
          <p:cNvPr id="56" name="Pentagon 55">
            <a:extLst>
              <a:ext uri="{FF2B5EF4-FFF2-40B4-BE49-F238E27FC236}">
                <a16:creationId xmlns:a16="http://schemas.microsoft.com/office/drawing/2014/main" id="{C4CFDE1A-796D-824A-AA4F-1D2EB83C4630}"/>
              </a:ext>
            </a:extLst>
          </p:cNvPr>
          <p:cNvSpPr/>
          <p:nvPr/>
        </p:nvSpPr>
        <p:spPr>
          <a:xfrm>
            <a:off x="2101439" y="908729"/>
            <a:ext cx="249261" cy="158951"/>
          </a:xfrm>
          <a:prstGeom prst="homePlate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 dirty="0">
              <a:solidFill>
                <a:schemeClr val="tx1"/>
              </a:solidFill>
            </a:endParaRPr>
          </a:p>
        </p:txBody>
      </p:sp>
      <p:sp>
        <p:nvSpPr>
          <p:cNvPr id="57" name="Pentagon 56">
            <a:extLst>
              <a:ext uri="{FF2B5EF4-FFF2-40B4-BE49-F238E27FC236}">
                <a16:creationId xmlns:a16="http://schemas.microsoft.com/office/drawing/2014/main" id="{611B5958-F0BE-5440-BB1F-25F1CB06DB94}"/>
              </a:ext>
            </a:extLst>
          </p:cNvPr>
          <p:cNvSpPr/>
          <p:nvPr/>
        </p:nvSpPr>
        <p:spPr>
          <a:xfrm>
            <a:off x="3279771" y="908729"/>
            <a:ext cx="320871" cy="158951"/>
          </a:xfrm>
          <a:prstGeom prst="homePlate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 dirty="0">
              <a:solidFill>
                <a:schemeClr val="tx1"/>
              </a:solidFill>
            </a:endParaRPr>
          </a:p>
        </p:txBody>
      </p:sp>
      <p:sp>
        <p:nvSpPr>
          <p:cNvPr id="58" name="Pentagon 57">
            <a:extLst>
              <a:ext uri="{FF2B5EF4-FFF2-40B4-BE49-F238E27FC236}">
                <a16:creationId xmlns:a16="http://schemas.microsoft.com/office/drawing/2014/main" id="{DE54F8D0-AEF9-9D4C-B4A8-AEBBCFD83DC5}"/>
              </a:ext>
            </a:extLst>
          </p:cNvPr>
          <p:cNvSpPr/>
          <p:nvPr/>
        </p:nvSpPr>
        <p:spPr>
          <a:xfrm>
            <a:off x="3628254" y="908729"/>
            <a:ext cx="244236" cy="158951"/>
          </a:xfrm>
          <a:prstGeom prst="homePlate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 dirty="0">
              <a:solidFill>
                <a:schemeClr val="tx1"/>
              </a:solidFill>
            </a:endParaRPr>
          </a:p>
        </p:txBody>
      </p:sp>
      <p:sp>
        <p:nvSpPr>
          <p:cNvPr id="59" name="Pentagon 58">
            <a:extLst>
              <a:ext uri="{FF2B5EF4-FFF2-40B4-BE49-F238E27FC236}">
                <a16:creationId xmlns:a16="http://schemas.microsoft.com/office/drawing/2014/main" id="{E3E02650-4B13-D84E-8E15-ECDF9CB98D2B}"/>
              </a:ext>
            </a:extLst>
          </p:cNvPr>
          <p:cNvSpPr/>
          <p:nvPr/>
        </p:nvSpPr>
        <p:spPr>
          <a:xfrm>
            <a:off x="1138207" y="908729"/>
            <a:ext cx="506680" cy="158951"/>
          </a:xfrm>
          <a:prstGeom prst="homePlate">
            <a:avLst/>
          </a:prstGeom>
          <a:solidFill>
            <a:schemeClr val="accent5">
              <a:lumMod val="40000"/>
              <a:lumOff val="60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 dirty="0">
              <a:solidFill>
                <a:schemeClr val="tx1"/>
              </a:solidFill>
            </a:endParaRPr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B512F75B-0A35-A344-9861-559CB1FBA7AA}"/>
              </a:ext>
            </a:extLst>
          </p:cNvPr>
          <p:cNvSpPr/>
          <p:nvPr/>
        </p:nvSpPr>
        <p:spPr>
          <a:xfrm>
            <a:off x="3951019" y="940526"/>
            <a:ext cx="56819" cy="87122"/>
          </a:xfrm>
          <a:prstGeom prst="rect">
            <a:avLst/>
          </a:prstGeom>
          <a:solidFill>
            <a:schemeClr val="bg1">
              <a:lumMod val="8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Diamond 60">
            <a:extLst>
              <a:ext uri="{FF2B5EF4-FFF2-40B4-BE49-F238E27FC236}">
                <a16:creationId xmlns:a16="http://schemas.microsoft.com/office/drawing/2014/main" id="{09917975-D562-C541-8742-8598E40ADCBD}"/>
              </a:ext>
            </a:extLst>
          </p:cNvPr>
          <p:cNvSpPr/>
          <p:nvPr/>
        </p:nvSpPr>
        <p:spPr>
          <a:xfrm>
            <a:off x="3891657" y="911486"/>
            <a:ext cx="45720" cy="137160"/>
          </a:xfrm>
          <a:prstGeom prst="diamond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7B486BA0-48DF-B341-A2F4-029189B0EDC8}"/>
              </a:ext>
            </a:extLst>
          </p:cNvPr>
          <p:cNvSpPr txBox="1"/>
          <p:nvPr/>
        </p:nvSpPr>
        <p:spPr>
          <a:xfrm>
            <a:off x="1185783" y="903492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i="1" dirty="0">
                <a:latin typeface="Arial" panose="020B0604020202020204" pitchFamily="34" charset="0"/>
                <a:cs typeface="Arial" panose="020B0604020202020204" pitchFamily="34" charset="0"/>
              </a:rPr>
              <a:t>cas3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9EDEDABE-47F1-864D-BD0E-CFD4D54F6DA5}"/>
              </a:ext>
            </a:extLst>
          </p:cNvPr>
          <p:cNvSpPr txBox="1"/>
          <p:nvPr/>
        </p:nvSpPr>
        <p:spPr>
          <a:xfrm>
            <a:off x="1704329" y="896359"/>
            <a:ext cx="34817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i="1" dirty="0">
                <a:latin typeface="Arial" panose="020B0604020202020204" pitchFamily="34" charset="0"/>
                <a:cs typeface="Arial" panose="020B0604020202020204" pitchFamily="34" charset="0"/>
              </a:rPr>
              <a:t>cas8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DD0621CF-B389-9342-A2F2-2B01F3EEFF0F}"/>
              </a:ext>
            </a:extLst>
          </p:cNvPr>
          <p:cNvSpPr txBox="1"/>
          <p:nvPr/>
        </p:nvSpPr>
        <p:spPr>
          <a:xfrm>
            <a:off x="2024493" y="895007"/>
            <a:ext cx="3914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i="1" dirty="0">
                <a:latin typeface="Arial" panose="020B0604020202020204" pitchFamily="34" charset="0"/>
                <a:cs typeface="Arial" panose="020B0604020202020204" pitchFamily="34" charset="0"/>
              </a:rPr>
              <a:t>cas11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67D014C7-D344-6C4D-AF9F-55A98BC2D04B}"/>
              </a:ext>
            </a:extLst>
          </p:cNvPr>
          <p:cNvSpPr txBox="1"/>
          <p:nvPr/>
        </p:nvSpPr>
        <p:spPr>
          <a:xfrm>
            <a:off x="2342709" y="895007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i="1" dirty="0">
                <a:latin typeface="Arial" panose="020B0604020202020204" pitchFamily="34" charset="0"/>
                <a:cs typeface="Arial" panose="020B0604020202020204" pitchFamily="34" charset="0"/>
              </a:rPr>
              <a:t>cas7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377FDCC4-CE65-CE46-8692-6D65E9D93CFA}"/>
              </a:ext>
            </a:extLst>
          </p:cNvPr>
          <p:cNvSpPr txBox="1"/>
          <p:nvPr/>
        </p:nvSpPr>
        <p:spPr>
          <a:xfrm>
            <a:off x="2942492" y="895007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i="1" dirty="0">
                <a:latin typeface="Arial" panose="020B0604020202020204" pitchFamily="34" charset="0"/>
                <a:cs typeface="Arial" panose="020B0604020202020204" pitchFamily="34" charset="0"/>
              </a:rPr>
              <a:t>cas6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AC83DE8D-8D19-5540-B12D-49706FB45F2B}"/>
              </a:ext>
            </a:extLst>
          </p:cNvPr>
          <p:cNvSpPr txBox="1"/>
          <p:nvPr/>
        </p:nvSpPr>
        <p:spPr>
          <a:xfrm>
            <a:off x="2653327" y="895007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i="1" dirty="0">
                <a:latin typeface="Arial" panose="020B0604020202020204" pitchFamily="34" charset="0"/>
                <a:cs typeface="Arial" panose="020B0604020202020204" pitchFamily="34" charset="0"/>
              </a:rPr>
              <a:t>cas5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6071F29F-A004-8A4A-911D-125D256D3E5D}"/>
              </a:ext>
            </a:extLst>
          </p:cNvPr>
          <p:cNvSpPr txBox="1"/>
          <p:nvPr/>
        </p:nvSpPr>
        <p:spPr>
          <a:xfrm>
            <a:off x="3243969" y="895007"/>
            <a:ext cx="3786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i="1" dirty="0">
                <a:latin typeface="Arial" panose="020B0604020202020204" pitchFamily="34" charset="0"/>
                <a:cs typeface="Arial" panose="020B0604020202020204" pitchFamily="34" charset="0"/>
              </a:rPr>
              <a:t>cas1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8969F831-D951-854E-854A-0FA8099FF382}"/>
              </a:ext>
            </a:extLst>
          </p:cNvPr>
          <p:cNvSpPr txBox="1"/>
          <p:nvPr/>
        </p:nvSpPr>
        <p:spPr>
          <a:xfrm>
            <a:off x="3563170" y="895007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i="1" dirty="0">
                <a:latin typeface="Arial" panose="020B0604020202020204" pitchFamily="34" charset="0"/>
                <a:cs typeface="Arial" panose="020B0604020202020204" pitchFamily="34" charset="0"/>
              </a:rPr>
              <a:t>cas2</a:t>
            </a:r>
          </a:p>
        </p:txBody>
      </p:sp>
      <p:sp>
        <p:nvSpPr>
          <p:cNvPr id="86" name="Diamond 85">
            <a:extLst>
              <a:ext uri="{FF2B5EF4-FFF2-40B4-BE49-F238E27FC236}">
                <a16:creationId xmlns:a16="http://schemas.microsoft.com/office/drawing/2014/main" id="{61F8F441-1A4C-964D-A3AB-A734E39BB22B}"/>
              </a:ext>
            </a:extLst>
          </p:cNvPr>
          <p:cNvSpPr/>
          <p:nvPr/>
        </p:nvSpPr>
        <p:spPr>
          <a:xfrm>
            <a:off x="4015331" y="911486"/>
            <a:ext cx="45720" cy="137160"/>
          </a:xfrm>
          <a:prstGeom prst="diamond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64B70F30-224A-A242-BDEC-CBB7C44B0BFC}"/>
              </a:ext>
            </a:extLst>
          </p:cNvPr>
          <p:cNvSpPr txBox="1"/>
          <p:nvPr/>
        </p:nvSpPr>
        <p:spPr>
          <a:xfrm>
            <a:off x="1204248" y="616937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24.72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8FB603A2-AC21-154B-B732-37B9DBF430CF}"/>
              </a:ext>
            </a:extLst>
          </p:cNvPr>
          <p:cNvSpPr txBox="1"/>
          <p:nvPr/>
        </p:nvSpPr>
        <p:spPr>
          <a:xfrm>
            <a:off x="1695308" y="616937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17.18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E33D39F7-2692-1F48-B3DB-099577677B65}"/>
              </a:ext>
            </a:extLst>
          </p:cNvPr>
          <p:cNvSpPr txBox="1"/>
          <p:nvPr/>
        </p:nvSpPr>
        <p:spPr>
          <a:xfrm>
            <a:off x="2013523" y="616937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19.81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DBA00915-408E-B64F-AC75-41788533E66B}"/>
              </a:ext>
            </a:extLst>
          </p:cNvPr>
          <p:cNvSpPr txBox="1"/>
          <p:nvPr/>
        </p:nvSpPr>
        <p:spPr>
          <a:xfrm>
            <a:off x="2331734" y="616937"/>
            <a:ext cx="3353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29.9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95B6A1AE-F615-124C-B4C7-21C098524433}"/>
              </a:ext>
            </a:extLst>
          </p:cNvPr>
          <p:cNvSpPr txBox="1"/>
          <p:nvPr/>
        </p:nvSpPr>
        <p:spPr>
          <a:xfrm>
            <a:off x="2648860" y="616937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28.24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41EE2838-09A4-4E41-A08A-7FE1E6047C8A}"/>
              </a:ext>
            </a:extLst>
          </p:cNvPr>
          <p:cNvSpPr txBox="1"/>
          <p:nvPr/>
        </p:nvSpPr>
        <p:spPr>
          <a:xfrm>
            <a:off x="2924052" y="616937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23.48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4B0C43FF-33BE-E640-8B1E-1C4C4D76E005}"/>
              </a:ext>
            </a:extLst>
          </p:cNvPr>
          <p:cNvSpPr txBox="1"/>
          <p:nvPr/>
        </p:nvSpPr>
        <p:spPr>
          <a:xfrm>
            <a:off x="3231942" y="616937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36.25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AA6E4210-0FBC-8F48-9C0B-F56F6CA2F2C9}"/>
              </a:ext>
            </a:extLst>
          </p:cNvPr>
          <p:cNvSpPr txBox="1"/>
          <p:nvPr/>
        </p:nvSpPr>
        <p:spPr>
          <a:xfrm>
            <a:off x="3555732" y="616937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29.81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A4977B7B-B68C-C746-A03A-B45589481FB2}"/>
              </a:ext>
            </a:extLst>
          </p:cNvPr>
          <p:cNvSpPr txBox="1"/>
          <p:nvPr/>
        </p:nvSpPr>
        <p:spPr>
          <a:xfrm>
            <a:off x="-47497" y="1948137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B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2D289CBC-444F-3740-9334-BDC0A55EC75D}"/>
              </a:ext>
            </a:extLst>
          </p:cNvPr>
          <p:cNvSpPr txBox="1"/>
          <p:nvPr/>
        </p:nvSpPr>
        <p:spPr>
          <a:xfrm>
            <a:off x="87308" y="9642037"/>
            <a:ext cx="18074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cs typeface="Arial" panose="020B0604020202020204" pitchFamily="34" charset="0"/>
              </a:rPr>
              <a:t>Supplementary Figure S2</a:t>
            </a:r>
          </a:p>
        </p:txBody>
      </p:sp>
      <p:pic>
        <p:nvPicPr>
          <p:cNvPr id="78" name="Picture 77" descr="A picture containing application&#10;&#10;Description automatically generated">
            <a:extLst>
              <a:ext uri="{FF2B5EF4-FFF2-40B4-BE49-F238E27FC236}">
                <a16:creationId xmlns:a16="http://schemas.microsoft.com/office/drawing/2014/main" id="{44F0778C-589C-CA4B-8A4B-EB7BA4AC182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7298" t="978" r="27213" b="1043"/>
          <a:stretch/>
        </p:blipFill>
        <p:spPr>
          <a:xfrm>
            <a:off x="241365" y="2124006"/>
            <a:ext cx="6211790" cy="7504686"/>
          </a:xfrm>
          <a:prstGeom prst="rect">
            <a:avLst/>
          </a:prstGeom>
        </p:spPr>
      </p:pic>
      <p:sp>
        <p:nvSpPr>
          <p:cNvPr id="79" name="TextBox 78">
            <a:extLst>
              <a:ext uri="{FF2B5EF4-FFF2-40B4-BE49-F238E27FC236}">
                <a16:creationId xmlns:a16="http://schemas.microsoft.com/office/drawing/2014/main" id="{438BF691-48A0-984E-9ABD-A9EEF53AF07B}"/>
              </a:ext>
            </a:extLst>
          </p:cNvPr>
          <p:cNvSpPr txBox="1"/>
          <p:nvPr/>
        </p:nvSpPr>
        <p:spPr>
          <a:xfrm>
            <a:off x="4181257" y="-47997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</a:t>
            </a:r>
          </a:p>
        </p:txBody>
      </p:sp>
      <p:pic>
        <p:nvPicPr>
          <p:cNvPr id="21" name="Picture 20" descr="A picture containing chart&#10;&#10;Description automatically generated">
            <a:extLst>
              <a:ext uri="{FF2B5EF4-FFF2-40B4-BE49-F238E27FC236}">
                <a16:creationId xmlns:a16="http://schemas.microsoft.com/office/drawing/2014/main" id="{266F6CD4-C779-A647-90B0-F07557D3F95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648"/>
          <a:stretch/>
        </p:blipFill>
        <p:spPr>
          <a:xfrm>
            <a:off x="4433212" y="65642"/>
            <a:ext cx="2257323" cy="20450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236327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053</TotalTime>
  <Words>38</Words>
  <Application>Microsoft Macintosh PowerPoint</Application>
  <PresentationFormat>A4 Paper (210x297 mm)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/>
  <cp:keywords/>
  <dc:description/>
  <cp:lastModifiedBy>Noelia Martínez Álvarez</cp:lastModifiedBy>
  <cp:revision>352</cp:revision>
  <cp:lastPrinted>2020-07-05T21:14:31Z</cp:lastPrinted>
  <dcterms:created xsi:type="dcterms:W3CDTF">2020-04-02T18:42:51Z</dcterms:created>
  <dcterms:modified xsi:type="dcterms:W3CDTF">2021-05-16T16:32:12Z</dcterms:modified>
  <cp:category/>
</cp:coreProperties>
</file>